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4ACFD65-DE26-48B2-A4D1-0DD537DA7311}" v="113" dt="2022-01-10T01:36:41.67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0" autoAdjust="0"/>
    <p:restoredTop sz="94660"/>
  </p:normalViewPr>
  <p:slideViewPr>
    <p:cSldViewPr snapToGrid="0">
      <p:cViewPr>
        <p:scale>
          <a:sx n="100" d="100"/>
          <a:sy n="100" d="100"/>
        </p:scale>
        <p:origin x="2024" y="-19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xandre" userId="2b2fb5af-1a8e-42b9-9a1c-9724d1b34ce9" providerId="ADAL" clId="{04ACFD65-DE26-48B2-A4D1-0DD537DA7311}"/>
    <pc:docChg chg="undo custSel modSld">
      <pc:chgData name="Alexandre" userId="2b2fb5af-1a8e-42b9-9a1c-9724d1b34ce9" providerId="ADAL" clId="{04ACFD65-DE26-48B2-A4D1-0DD537DA7311}" dt="2022-01-10T01:36:39.853" v="1326" actId="164"/>
      <pc:docMkLst>
        <pc:docMk/>
      </pc:docMkLst>
      <pc:sldChg chg="addSp modSp mod">
        <pc:chgData name="Alexandre" userId="2b2fb5af-1a8e-42b9-9a1c-9724d1b34ce9" providerId="ADAL" clId="{04ACFD65-DE26-48B2-A4D1-0DD537DA7311}" dt="2022-01-10T01:36:39.853" v="1326" actId="164"/>
        <pc:sldMkLst>
          <pc:docMk/>
          <pc:sldMk cId="2719727650" sldId="256"/>
        </pc:sldMkLst>
        <pc:spChg chg="mod">
          <ac:chgData name="Alexandre" userId="2b2fb5af-1a8e-42b9-9a1c-9724d1b34ce9" providerId="ADAL" clId="{04ACFD65-DE26-48B2-A4D1-0DD537DA7311}" dt="2022-01-10T01:36:39.853" v="1326" actId="164"/>
          <ac:spMkLst>
            <pc:docMk/>
            <pc:sldMk cId="2719727650" sldId="256"/>
            <ac:spMk id="7" creationId="{543C05A5-DBBA-4D90-B4B9-D7723E71830F}"/>
          </ac:spMkLst>
        </pc:spChg>
        <pc:spChg chg="add mod">
          <ac:chgData name="Alexandre" userId="2b2fb5af-1a8e-42b9-9a1c-9724d1b34ce9" providerId="ADAL" clId="{04ACFD65-DE26-48B2-A4D1-0DD537DA7311}" dt="2022-01-10T01:36:39.853" v="1326" actId="164"/>
          <ac:spMkLst>
            <pc:docMk/>
            <pc:sldMk cId="2719727650" sldId="256"/>
            <ac:spMk id="8" creationId="{32834ACB-938C-4FB5-8B02-3463646A3D32}"/>
          </ac:spMkLst>
        </pc:spChg>
        <pc:spChg chg="add mod">
          <ac:chgData name="Alexandre" userId="2b2fb5af-1a8e-42b9-9a1c-9724d1b34ce9" providerId="ADAL" clId="{04ACFD65-DE26-48B2-A4D1-0DD537DA7311}" dt="2022-01-10T01:36:39.853" v="1326" actId="164"/>
          <ac:spMkLst>
            <pc:docMk/>
            <pc:sldMk cId="2719727650" sldId="256"/>
            <ac:spMk id="9" creationId="{088F1FFA-4DE3-4D34-AA38-AD064D98591A}"/>
          </ac:spMkLst>
        </pc:spChg>
        <pc:grpChg chg="add mod">
          <ac:chgData name="Alexandre" userId="2b2fb5af-1a8e-42b9-9a1c-9724d1b34ce9" providerId="ADAL" clId="{04ACFD65-DE26-48B2-A4D1-0DD537DA7311}" dt="2022-01-10T01:36:39.853" v="1326" actId="164"/>
          <ac:grpSpMkLst>
            <pc:docMk/>
            <pc:sldMk cId="2719727650" sldId="256"/>
            <ac:grpSpMk id="10" creationId="{82AA0758-04B9-4B27-8868-85C9857DB1A7}"/>
          </ac:grpSpMkLst>
        </pc:grpChg>
        <pc:graphicFrameChg chg="mod">
          <ac:chgData name="Alexandre" userId="2b2fb5af-1a8e-42b9-9a1c-9724d1b34ce9" providerId="ADAL" clId="{04ACFD65-DE26-48B2-A4D1-0DD537DA7311}" dt="2022-01-10T01:36:39.853" v="1326" actId="164"/>
          <ac:graphicFrameMkLst>
            <pc:docMk/>
            <pc:sldMk cId="2719727650" sldId="256"/>
            <ac:graphicFrameMk id="5" creationId="{103888DF-4F96-4BDD-B699-C35DE7982FC1}"/>
          </ac:graphicFrameMkLst>
        </pc:graphicFrameChg>
        <pc:graphicFrameChg chg="mod">
          <ac:chgData name="Alexandre" userId="2b2fb5af-1a8e-42b9-9a1c-9724d1b34ce9" providerId="ADAL" clId="{04ACFD65-DE26-48B2-A4D1-0DD537DA7311}" dt="2022-01-10T01:36:39.853" v="1326" actId="164"/>
          <ac:graphicFrameMkLst>
            <pc:docMk/>
            <pc:sldMk cId="2719727650" sldId="256"/>
            <ac:graphicFrameMk id="6" creationId="{2E4788A3-5024-413D-B836-DB57BB743B95}"/>
          </ac:graphicFrameMkLst>
        </pc:graphicFrame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9872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04204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1572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5617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7885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72512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65908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746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0372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7777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72822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7D3122-9873-4C94-8F34-3ECD04964183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552F8E-9541-416D-8486-E41B6BBF98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5335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82AA0758-04B9-4B27-8868-85C9857DB1A7}"/>
              </a:ext>
            </a:extLst>
          </p:cNvPr>
          <p:cNvGrpSpPr/>
          <p:nvPr/>
        </p:nvGrpSpPr>
        <p:grpSpPr>
          <a:xfrm>
            <a:off x="493568" y="513681"/>
            <a:ext cx="5787460" cy="8601639"/>
            <a:chOff x="493568" y="513681"/>
            <a:chExt cx="5787460" cy="8601639"/>
          </a:xfrm>
        </p:grpSpPr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103888DF-4F96-4BDD-B699-C35DE7982FC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59535967"/>
                </p:ext>
              </p:extLst>
            </p:nvPr>
          </p:nvGraphicFramePr>
          <p:xfrm>
            <a:off x="576776" y="717335"/>
            <a:ext cx="5704252" cy="359882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5" name="Prism 9" r:id="rId3" imgW="9529790" imgH="6009919" progId="Prism9.Document">
                    <p:embed/>
                  </p:oleObj>
                </mc:Choice>
                <mc:Fallback>
                  <p:oleObj name="Prism 9" r:id="rId3" imgW="9529790" imgH="6009919" progId="Prism9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103888DF-4F96-4BDD-B699-C35DE7982FC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576776" y="717335"/>
                          <a:ext cx="5704252" cy="359882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2E4788A3-5024-413D-B836-DB57BB743B9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70423841"/>
                </p:ext>
              </p:extLst>
            </p:nvPr>
          </p:nvGraphicFramePr>
          <p:xfrm>
            <a:off x="576972" y="4316163"/>
            <a:ext cx="5697978" cy="359882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6" name="Prism 9" r:id="rId5" imgW="9528350" imgH="6009919" progId="Prism9.Document">
                    <p:embed/>
                  </p:oleObj>
                </mc:Choice>
                <mc:Fallback>
                  <p:oleObj name="Prism 9" r:id="rId5" imgW="9528350" imgH="6009919" progId="Prism9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2E4788A3-5024-413D-B836-DB57BB743B9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576972" y="4316163"/>
                          <a:ext cx="5697978" cy="359882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43C05A5-DBBA-4D90-B4B9-D7723E71830F}"/>
                </a:ext>
              </a:extLst>
            </p:cNvPr>
            <p:cNvSpPr txBox="1"/>
            <p:nvPr/>
          </p:nvSpPr>
          <p:spPr>
            <a:xfrm>
              <a:off x="583050" y="7914991"/>
              <a:ext cx="5691900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GB" sz="800" b="1" dirty="0"/>
                <a:t>Supplementary Figure S5. Impact of RNAi targeted against individual HHL signalling genes on the severe stress resistance of adult </a:t>
              </a:r>
              <a:r>
                <a:rPr lang="en-GB" sz="800" b="1" i="1" dirty="0"/>
                <a:t>C. elegans </a:t>
              </a:r>
              <a:r>
                <a:rPr lang="en-GB" sz="800" b="1" dirty="0"/>
                <a:t>exposed to </a:t>
              </a:r>
              <a:r>
                <a:rPr lang="en-GB" sz="800" b="1" i="1" dirty="0"/>
                <a:t>B. subtilis sp. </a:t>
              </a:r>
              <a:r>
                <a:rPr lang="en-GB" sz="800" b="1" dirty="0"/>
                <a:t>168 and </a:t>
              </a:r>
              <a:r>
                <a:rPr lang="en-GB" sz="800" b="1" i="1" dirty="0" err="1"/>
                <a:t>Comomonas</a:t>
              </a:r>
              <a:r>
                <a:rPr lang="en-GB" sz="800" b="1" i="1" dirty="0"/>
                <a:t> sp. </a:t>
              </a:r>
              <a:r>
                <a:rPr lang="en-GB" sz="800" b="1" dirty="0"/>
                <a:t>MYb21. </a:t>
              </a:r>
              <a:r>
                <a:rPr lang="en-GB" sz="800" dirty="0"/>
                <a:t>Genes targeted by RNAi are ordered based on phylogenetic relationships (cf. previous figures). </a:t>
              </a:r>
              <a:r>
                <a:rPr lang="en-GB" sz="800" b="1" dirty="0"/>
                <a:t>(A) </a:t>
              </a:r>
              <a:r>
                <a:rPr lang="en-GB" sz="800" dirty="0"/>
                <a:t>Resistance to exposure to 7% tert-butyl hydroperoxide (</a:t>
              </a:r>
              <a:r>
                <a:rPr lang="en-GB" sz="800" dirty="0" err="1"/>
                <a:t>tBHP</a:t>
              </a:r>
              <a:r>
                <a:rPr lang="en-GB" sz="800" dirty="0"/>
                <a:t>). 2-way ANOVA did not identify significant effects of RNAi or isolate identity on oxidative stress resistance, but it revealed that individual RNAi differentially affects each isolate. </a:t>
              </a:r>
              <a:r>
                <a:rPr lang="en-GB" sz="800" b="1" dirty="0"/>
                <a:t>(B) </a:t>
              </a:r>
              <a:r>
                <a:rPr lang="en-GB" sz="800" dirty="0"/>
                <a:t>Resistance to exposure to 42</a:t>
              </a:r>
              <a:r>
                <a:rPr lang="en-GB" sz="800" baseline="30000" dirty="0"/>
                <a:t>o</a:t>
              </a:r>
              <a:r>
                <a:rPr lang="en-GB" sz="800" dirty="0"/>
                <a:t>C thermal stress. 2-way ANOVA revealed a significant effect of RNAi, isolate identity and their interaction on heat stress resistance. In particular RNAi-targeted adult worms generally displayed higher heat stress resistance following transfer onto MYb21 compared to </a:t>
              </a:r>
              <a:r>
                <a:rPr lang="en-GB" sz="800" i="1" dirty="0"/>
                <a:t>B. subtilis</a:t>
              </a:r>
              <a:r>
                <a:rPr lang="en-GB" sz="800" dirty="0"/>
                <a:t>. Several RNAi lowered adult worm heat stress resistance on either or both bacteria. Data were acquired for 2 to 6 biological replicates per condition in three independent LFASS assays (Benedetto et al. 2019).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2834ACB-938C-4FB5-8B02-3463646A3D32}"/>
                </a:ext>
              </a:extLst>
            </p:cNvPr>
            <p:cNvSpPr txBox="1"/>
            <p:nvPr/>
          </p:nvSpPr>
          <p:spPr>
            <a:xfrm>
              <a:off x="493568" y="513681"/>
              <a:ext cx="3738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(A)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88F1FFA-4DE3-4D34-AA38-AD064D98591A}"/>
                </a:ext>
              </a:extLst>
            </p:cNvPr>
            <p:cNvSpPr txBox="1"/>
            <p:nvPr/>
          </p:nvSpPr>
          <p:spPr>
            <a:xfrm>
              <a:off x="493568" y="4177663"/>
              <a:ext cx="367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/>
                <a:t>(B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19727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13811305467C74494CB40DB3D5262DA" ma:contentTypeVersion="8" ma:contentTypeDescription="Create a new document." ma:contentTypeScope="" ma:versionID="8fc5784638860716a3723dffd2d08673">
  <xsd:schema xmlns:xsd="http://www.w3.org/2001/XMLSchema" xmlns:xs="http://www.w3.org/2001/XMLSchema" xmlns:p="http://schemas.microsoft.com/office/2006/metadata/properties" xmlns:ns2="c0db18e3-4c06-4c9d-ab15-91da0ad61027" targetNamespace="http://schemas.microsoft.com/office/2006/metadata/properties" ma:root="true" ma:fieldsID="e03991102f04ff9dcf3a5d4219758345" ns2:_="">
    <xsd:import namespace="c0db18e3-4c06-4c9d-ab15-91da0ad61027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0db18e3-4c06-4c9d-ab15-91da0ad6102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63E7BB5A-6D57-40D5-8AB5-E3E9B1EDCED9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FF6CD2D1-A8D4-42D8-963E-1EADBF88936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3D83B37-D9AA-47A9-8F28-47E1F3B5430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0db18e3-4c06-4c9d-ab15-91da0ad6102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</TotalTime>
  <Words>189</Words>
  <Application>Microsoft Macintosh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andre Benedetto</dc:creator>
  <cp:lastModifiedBy>Alejandra Zarate</cp:lastModifiedBy>
  <cp:revision>2</cp:revision>
  <dcterms:created xsi:type="dcterms:W3CDTF">2022-01-10T01:07:21Z</dcterms:created>
  <dcterms:modified xsi:type="dcterms:W3CDTF">2022-02-28T10:46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13811305467C74494CB40DB3D5262DA</vt:lpwstr>
  </property>
</Properties>
</file>